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94" d="100"/>
          <a:sy n="94" d="100"/>
        </p:scale>
        <p:origin x="197" y="-931"/>
      </p:cViewPr>
      <p:guideLst>
        <p:guide orient="horz" pos="3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C7922-0F99-D42D-4AAE-67C6EA9A90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4FCB41-6E7E-66FC-E984-AA3729793A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6050BA-D985-0D7E-18F1-915B7E826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FA1A77-BBB9-6A08-5089-DFBCF30F2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2E022-B7A1-1B7F-ED1A-1A7282CFB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596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48519-38F3-97B0-0322-7EEE6A2E0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41EA3E-59A8-371F-26B6-BEB4F3FE49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B6F74C-F470-E7A4-B0AE-59751CDBC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C367BA-8B34-963B-3D7D-F9F21A6E0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702DF9-65BF-E4B5-F325-E08EA2190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786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F75145-B814-CC23-3AD2-8119554066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CE4BDF-0756-9362-D463-9A9B706204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C073E-8C05-344D-7FE8-44B2192DD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249B9B-9666-AA29-CA15-3BEDF1E1E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E17F91-1C23-3688-CD3A-2BEF23617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91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00099-612D-F68B-B0CC-46955703CA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3C22BD-C12F-8919-0B15-7B622F5B4C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818C8-CA58-EBA8-F61A-F954D7EB5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60FE7B-000E-706F-2797-3D0BA2AC8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420FAA-9E51-BEF4-998B-1962B48AD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726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CA24F-244A-7724-185A-8E35BDE0B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82DE26-E52E-38B7-4011-0105E9692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0D4D9-4E99-5D22-902D-67A786AA9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373195-702F-575A-84B9-D35F1DA5C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784E4-D6F3-E449-6C91-19F823538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121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F0E835-0F95-E858-53CD-1788C17537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13AE4-3F3A-9A42-C920-1F5057F47E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7E587C-09DD-0A5E-C9C3-5AC58875D3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03EC93-4DD2-6EF2-9FAC-AA6FA852B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7FE3AA-47B5-7786-FC5B-B1E868A20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54FDC3-3A33-3814-99E4-7D14E8C37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824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AC90F-CACE-73CF-E9C2-2BA83B502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99725A-088F-97F1-746B-B49BADF65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1C6CFF-4C51-D635-A2D7-BE50BF1073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DB7002-3D98-5C30-CF48-DE9C50BA0B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BF8DA3-808A-7C03-616A-39343F7ACB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2C3700-86E5-DADF-4823-B937B7E6A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356B2-A9F1-187C-8564-36BAA92D6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6D54BA-4331-4F29-E224-27B83E836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322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8DC586-F29B-FA16-1032-9865D250B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FEFAF1-E7FF-8939-DD54-872DE880D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7D4E38-7974-66DF-28AD-D6D15523F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07D744-5E04-C3AD-263F-BFA78DFD1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682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5FD72E-8292-4626-4E11-6008808C9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F051B4-FE8F-7921-E1E7-B0D911D7E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AA2B11-076F-F607-4B5C-D4BF10A3D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64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F0B52-89E4-2966-64D6-0B00CE98E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78A28A-74B1-F20E-78A7-8087CC2313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7B4541-05B6-4586-9D3B-8EEEF19B0D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3F9649-54BB-8546-C0DE-E6076C546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253FD6-2118-64EA-AAFD-FA6136BAC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D1AEBF-1582-C3DC-3CAF-7C76B5C60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868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A4811C-7207-0BDC-9165-421C512DB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956006-C373-67EA-C1E6-94D7CFC6D9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6F7AB8-E292-57DD-D22E-F4D5A066A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98FACE-BABC-3AD1-13E0-49FFE6AC9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E06A96-FEA4-1A4D-B52D-2D5D20A97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9F2AFD-9996-AF85-7CDA-18966C7D4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68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D4DDBD-D5A1-9C5D-4657-399593B2C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714D3A-645E-8974-A413-0A54911704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645260-0D98-AAC5-CA18-442A48BC1C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19AEFD-07CA-47B9-9370-4EAF5AB7C93C}" type="datetimeFigureOut">
              <a:rPr lang="en-US" smtClean="0"/>
              <a:t>1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E8A80F-0DB4-1394-47E2-315EBD299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BB29E6-DB26-1379-3980-8C709424DC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D281B1-7C88-40BC-99F3-76CC81911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930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96123A96-248A-F99D-7C46-08ED1CE5B836}"/>
              </a:ext>
            </a:extLst>
          </p:cNvPr>
          <p:cNvSpPr txBox="1"/>
          <p:nvPr/>
        </p:nvSpPr>
        <p:spPr>
          <a:xfrm>
            <a:off x="33973" y="196634"/>
            <a:ext cx="20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  <a:endParaRPr lang="el-GR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2B5E6FC-10B7-CE5B-2741-029483A1448A}"/>
              </a:ext>
            </a:extLst>
          </p:cNvPr>
          <p:cNvSpPr txBox="1"/>
          <p:nvPr/>
        </p:nvSpPr>
        <p:spPr>
          <a:xfrm>
            <a:off x="5903659" y="381300"/>
            <a:ext cx="20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  <a:endParaRPr lang="el-GR" dirty="0"/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76D1FA5-4E10-6B70-40B4-4EFA715BFE6C}"/>
              </a:ext>
            </a:extLst>
          </p:cNvPr>
          <p:cNvGrpSpPr/>
          <p:nvPr/>
        </p:nvGrpSpPr>
        <p:grpSpPr>
          <a:xfrm>
            <a:off x="7890533" y="3404618"/>
            <a:ext cx="4140303" cy="3334650"/>
            <a:chOff x="7890533" y="3512198"/>
            <a:chExt cx="4140303" cy="333465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8365F2C-2F90-96CB-FEC9-C75B2C6A57DA}"/>
                </a:ext>
              </a:extLst>
            </p:cNvPr>
            <p:cNvSpPr txBox="1"/>
            <p:nvPr/>
          </p:nvSpPr>
          <p:spPr>
            <a:xfrm>
              <a:off x="7890533" y="3512198"/>
              <a:ext cx="3668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e</a:t>
              </a:r>
              <a:endParaRPr lang="el-GR" dirty="0"/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44AD853C-B70F-0B8F-41A8-2F0B5DE067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7349" y="3586033"/>
              <a:ext cx="3782009" cy="3105583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46CDAD1D-F309-40E2-5853-F6833E5548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54" t="9881" b="64790"/>
            <a:stretch>
              <a:fillRect/>
            </a:stretch>
          </p:blipFill>
          <p:spPr>
            <a:xfrm>
              <a:off x="10697592" y="3626712"/>
              <a:ext cx="1333244" cy="1440805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E4BF39C-5301-3799-2B71-A7DC61C57641}"/>
                </a:ext>
              </a:extLst>
            </p:cNvPr>
            <p:cNvSpPr txBox="1"/>
            <p:nvPr/>
          </p:nvSpPr>
          <p:spPr>
            <a:xfrm rot="16200000">
              <a:off x="7164842" y="4942560"/>
              <a:ext cx="2491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/>
                <a:t>CD274 (PD-L1): Z-scores of protein abundance ratios relative to bridge-samples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3B6664D-DF66-4C5A-DC5B-94573C6ABB3B}"/>
                </a:ext>
              </a:extLst>
            </p:cNvPr>
            <p:cNvSpPr txBox="1"/>
            <p:nvPr/>
          </p:nvSpPr>
          <p:spPr>
            <a:xfrm>
              <a:off x="8709641" y="6477516"/>
              <a:ext cx="2491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/>
                <a:t>TRAF3: Z-scores of protein abundance ratios relative to bridge-samples</a:t>
              </a:r>
            </a:p>
          </p:txBody>
        </p:sp>
      </p:grpSp>
      <p:pic>
        <p:nvPicPr>
          <p:cNvPr id="46" name="Picture 45">
            <a:extLst>
              <a:ext uri="{FF2B5EF4-FFF2-40B4-BE49-F238E27FC236}">
                <a16:creationId xmlns:a16="http://schemas.microsoft.com/office/drawing/2014/main" id="{51A7354E-ED04-7517-E8BD-DDEA4D60F6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2412" y="4051563"/>
            <a:ext cx="3393743" cy="2545308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556AFDE6-AE0A-8730-72FB-559BA70DDC6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12" y="4051563"/>
            <a:ext cx="3393742" cy="2545307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sp>
        <p:nvSpPr>
          <p:cNvPr id="49" name="Isosceles Triangle 48">
            <a:extLst>
              <a:ext uri="{FF2B5EF4-FFF2-40B4-BE49-F238E27FC236}">
                <a16:creationId xmlns:a16="http://schemas.microsoft.com/office/drawing/2014/main" id="{8122460F-F64F-467B-1DFC-657B08661D9F}"/>
              </a:ext>
            </a:extLst>
          </p:cNvPr>
          <p:cNvSpPr/>
          <p:nvPr/>
        </p:nvSpPr>
        <p:spPr>
          <a:xfrm>
            <a:off x="2178333" y="5021438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>
            <a:extLst>
              <a:ext uri="{FF2B5EF4-FFF2-40B4-BE49-F238E27FC236}">
                <a16:creationId xmlns:a16="http://schemas.microsoft.com/office/drawing/2014/main" id="{361EEDA5-BB90-E20E-3E12-15E223EDD709}"/>
              </a:ext>
            </a:extLst>
          </p:cNvPr>
          <p:cNvSpPr/>
          <p:nvPr/>
        </p:nvSpPr>
        <p:spPr>
          <a:xfrm>
            <a:off x="1879759" y="4918199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>
            <a:extLst>
              <a:ext uri="{FF2B5EF4-FFF2-40B4-BE49-F238E27FC236}">
                <a16:creationId xmlns:a16="http://schemas.microsoft.com/office/drawing/2014/main" id="{406A7F3F-29F5-3C8F-934C-C533813DE8D6}"/>
              </a:ext>
            </a:extLst>
          </p:cNvPr>
          <p:cNvSpPr/>
          <p:nvPr/>
        </p:nvSpPr>
        <p:spPr>
          <a:xfrm>
            <a:off x="669082" y="5324216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Isosceles Triangle 51">
            <a:extLst>
              <a:ext uri="{FF2B5EF4-FFF2-40B4-BE49-F238E27FC236}">
                <a16:creationId xmlns:a16="http://schemas.microsoft.com/office/drawing/2014/main" id="{98EF3804-D545-E8BF-F9A8-B8F0CCE11516}"/>
              </a:ext>
            </a:extLst>
          </p:cNvPr>
          <p:cNvSpPr/>
          <p:nvPr/>
        </p:nvSpPr>
        <p:spPr>
          <a:xfrm>
            <a:off x="442688" y="4420895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Isosceles Triangle 52">
            <a:extLst>
              <a:ext uri="{FF2B5EF4-FFF2-40B4-BE49-F238E27FC236}">
                <a16:creationId xmlns:a16="http://schemas.microsoft.com/office/drawing/2014/main" id="{BF23353D-9998-6A63-E3B4-E794912C0F6B}"/>
              </a:ext>
            </a:extLst>
          </p:cNvPr>
          <p:cNvSpPr/>
          <p:nvPr/>
        </p:nvSpPr>
        <p:spPr>
          <a:xfrm>
            <a:off x="878539" y="4657645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Isosceles Triangle 53">
            <a:extLst>
              <a:ext uri="{FF2B5EF4-FFF2-40B4-BE49-F238E27FC236}">
                <a16:creationId xmlns:a16="http://schemas.microsoft.com/office/drawing/2014/main" id="{4083AF3F-6D29-E797-B6FA-4F82EAE4DABE}"/>
              </a:ext>
            </a:extLst>
          </p:cNvPr>
          <p:cNvSpPr/>
          <p:nvPr/>
        </p:nvSpPr>
        <p:spPr>
          <a:xfrm>
            <a:off x="1158835" y="4347114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Isosceles Triangle 54">
            <a:extLst>
              <a:ext uri="{FF2B5EF4-FFF2-40B4-BE49-F238E27FC236}">
                <a16:creationId xmlns:a16="http://schemas.microsoft.com/office/drawing/2014/main" id="{FF1BEAA0-D90E-0023-91BD-7B073EE1E8F6}"/>
              </a:ext>
            </a:extLst>
          </p:cNvPr>
          <p:cNvSpPr/>
          <p:nvPr/>
        </p:nvSpPr>
        <p:spPr>
          <a:xfrm>
            <a:off x="2792849" y="6073490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Isosceles Triangle 55">
            <a:extLst>
              <a:ext uri="{FF2B5EF4-FFF2-40B4-BE49-F238E27FC236}">
                <a16:creationId xmlns:a16="http://schemas.microsoft.com/office/drawing/2014/main" id="{4A5E3EA1-33BE-741A-2F7C-79266E9BBDB0}"/>
              </a:ext>
            </a:extLst>
          </p:cNvPr>
          <p:cNvSpPr/>
          <p:nvPr/>
        </p:nvSpPr>
        <p:spPr>
          <a:xfrm>
            <a:off x="2280133" y="6349883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Isosceles Triangle 56">
            <a:extLst>
              <a:ext uri="{FF2B5EF4-FFF2-40B4-BE49-F238E27FC236}">
                <a16:creationId xmlns:a16="http://schemas.microsoft.com/office/drawing/2014/main" id="{3EC5DE49-4352-EBB0-A0C8-C9CBEC75CEF0}"/>
              </a:ext>
            </a:extLst>
          </p:cNvPr>
          <p:cNvSpPr/>
          <p:nvPr/>
        </p:nvSpPr>
        <p:spPr>
          <a:xfrm>
            <a:off x="1077757" y="6431437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Isosceles Triangle 57">
            <a:extLst>
              <a:ext uri="{FF2B5EF4-FFF2-40B4-BE49-F238E27FC236}">
                <a16:creationId xmlns:a16="http://schemas.microsoft.com/office/drawing/2014/main" id="{A32A9C12-D69A-D9F5-6F6C-A92CC5AC55BE}"/>
              </a:ext>
            </a:extLst>
          </p:cNvPr>
          <p:cNvSpPr/>
          <p:nvPr/>
        </p:nvSpPr>
        <p:spPr>
          <a:xfrm>
            <a:off x="2333243" y="5370295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Isosceles Triangle 58">
            <a:extLst>
              <a:ext uri="{FF2B5EF4-FFF2-40B4-BE49-F238E27FC236}">
                <a16:creationId xmlns:a16="http://schemas.microsoft.com/office/drawing/2014/main" id="{C0312A46-CFFB-FCC6-E783-4292DE77E2CA}"/>
              </a:ext>
            </a:extLst>
          </p:cNvPr>
          <p:cNvSpPr/>
          <p:nvPr/>
        </p:nvSpPr>
        <p:spPr>
          <a:xfrm>
            <a:off x="4892036" y="6027411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Isosceles Triangle 59">
            <a:extLst>
              <a:ext uri="{FF2B5EF4-FFF2-40B4-BE49-F238E27FC236}">
                <a16:creationId xmlns:a16="http://schemas.microsoft.com/office/drawing/2014/main" id="{8F575399-4083-39AF-879C-E1D03E85511E}"/>
              </a:ext>
            </a:extLst>
          </p:cNvPr>
          <p:cNvSpPr/>
          <p:nvPr/>
        </p:nvSpPr>
        <p:spPr>
          <a:xfrm>
            <a:off x="5531133" y="4941238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Isosceles Triangle 60">
            <a:extLst>
              <a:ext uri="{FF2B5EF4-FFF2-40B4-BE49-F238E27FC236}">
                <a16:creationId xmlns:a16="http://schemas.microsoft.com/office/drawing/2014/main" id="{774D95E5-C90F-5B45-6FDD-B4C734D161FF}"/>
              </a:ext>
            </a:extLst>
          </p:cNvPr>
          <p:cNvSpPr/>
          <p:nvPr/>
        </p:nvSpPr>
        <p:spPr>
          <a:xfrm>
            <a:off x="6878153" y="5798186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Isosceles Triangle 61">
            <a:extLst>
              <a:ext uri="{FF2B5EF4-FFF2-40B4-BE49-F238E27FC236}">
                <a16:creationId xmlns:a16="http://schemas.microsoft.com/office/drawing/2014/main" id="{635F37DC-C3F2-517D-904F-1C0CA53439E4}"/>
              </a:ext>
            </a:extLst>
          </p:cNvPr>
          <p:cNvSpPr/>
          <p:nvPr/>
        </p:nvSpPr>
        <p:spPr>
          <a:xfrm>
            <a:off x="3988109" y="4998398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Isosceles Triangle 62">
            <a:extLst>
              <a:ext uri="{FF2B5EF4-FFF2-40B4-BE49-F238E27FC236}">
                <a16:creationId xmlns:a16="http://schemas.microsoft.com/office/drawing/2014/main" id="{E03C86B7-E56F-9D5C-F299-09F906B7EEC4}"/>
              </a:ext>
            </a:extLst>
          </p:cNvPr>
          <p:cNvSpPr/>
          <p:nvPr/>
        </p:nvSpPr>
        <p:spPr>
          <a:xfrm>
            <a:off x="4766148" y="6454476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Isosceles Triangle 63">
            <a:extLst>
              <a:ext uri="{FF2B5EF4-FFF2-40B4-BE49-F238E27FC236}">
                <a16:creationId xmlns:a16="http://schemas.microsoft.com/office/drawing/2014/main" id="{4864DB9F-5AF9-71CC-A600-0C52B8F86F6A}"/>
              </a:ext>
            </a:extLst>
          </p:cNvPr>
          <p:cNvSpPr/>
          <p:nvPr/>
        </p:nvSpPr>
        <p:spPr>
          <a:xfrm>
            <a:off x="5351618" y="4549490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Isosceles Triangle 64">
            <a:extLst>
              <a:ext uri="{FF2B5EF4-FFF2-40B4-BE49-F238E27FC236}">
                <a16:creationId xmlns:a16="http://schemas.microsoft.com/office/drawing/2014/main" id="{4D8CFB0A-C206-894C-18F5-5999744F9CF3}"/>
              </a:ext>
            </a:extLst>
          </p:cNvPr>
          <p:cNvSpPr/>
          <p:nvPr/>
        </p:nvSpPr>
        <p:spPr>
          <a:xfrm>
            <a:off x="546178" y="5798186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Isosceles Triangle 65">
            <a:extLst>
              <a:ext uri="{FF2B5EF4-FFF2-40B4-BE49-F238E27FC236}">
                <a16:creationId xmlns:a16="http://schemas.microsoft.com/office/drawing/2014/main" id="{F5410842-0393-CBAC-E265-29B5B6818033}"/>
              </a:ext>
            </a:extLst>
          </p:cNvPr>
          <p:cNvSpPr/>
          <p:nvPr/>
        </p:nvSpPr>
        <p:spPr>
          <a:xfrm>
            <a:off x="962640" y="5347255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Isosceles Triangle 66">
            <a:extLst>
              <a:ext uri="{FF2B5EF4-FFF2-40B4-BE49-F238E27FC236}">
                <a16:creationId xmlns:a16="http://schemas.microsoft.com/office/drawing/2014/main" id="{92857C51-4744-2E9E-3EDE-239B6351D819}"/>
              </a:ext>
            </a:extLst>
          </p:cNvPr>
          <p:cNvSpPr/>
          <p:nvPr/>
        </p:nvSpPr>
        <p:spPr>
          <a:xfrm>
            <a:off x="1958214" y="5241707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Isosceles Triangle 67">
            <a:extLst>
              <a:ext uri="{FF2B5EF4-FFF2-40B4-BE49-F238E27FC236}">
                <a16:creationId xmlns:a16="http://schemas.microsoft.com/office/drawing/2014/main" id="{84A9A941-4BE6-07C2-D8EC-A9A09DF1B996}"/>
              </a:ext>
            </a:extLst>
          </p:cNvPr>
          <p:cNvSpPr/>
          <p:nvPr/>
        </p:nvSpPr>
        <p:spPr>
          <a:xfrm>
            <a:off x="2330324" y="4595569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Isosceles Triangle 68">
            <a:extLst>
              <a:ext uri="{FF2B5EF4-FFF2-40B4-BE49-F238E27FC236}">
                <a16:creationId xmlns:a16="http://schemas.microsoft.com/office/drawing/2014/main" id="{1AB56458-4346-64C2-3877-315D0D568D80}"/>
              </a:ext>
            </a:extLst>
          </p:cNvPr>
          <p:cNvSpPr/>
          <p:nvPr/>
        </p:nvSpPr>
        <p:spPr>
          <a:xfrm>
            <a:off x="5703198" y="5670368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Isosceles Triangle 69">
            <a:extLst>
              <a:ext uri="{FF2B5EF4-FFF2-40B4-BE49-F238E27FC236}">
                <a16:creationId xmlns:a16="http://schemas.microsoft.com/office/drawing/2014/main" id="{ECF6193E-7576-9465-7AF9-618E3BF08D84}"/>
              </a:ext>
            </a:extLst>
          </p:cNvPr>
          <p:cNvSpPr/>
          <p:nvPr/>
        </p:nvSpPr>
        <p:spPr>
          <a:xfrm>
            <a:off x="1437719" y="5844265"/>
            <a:ext cx="45719" cy="46079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7001FB6-B9C4-158D-0EFF-F94F465D437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1455" y="259749"/>
            <a:ext cx="3782009" cy="3094371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29F9B736-2176-E8AF-AB97-FA258ADE3C78}"/>
              </a:ext>
            </a:extLst>
          </p:cNvPr>
          <p:cNvSpPr txBox="1"/>
          <p:nvPr/>
        </p:nvSpPr>
        <p:spPr>
          <a:xfrm>
            <a:off x="124567" y="3586033"/>
            <a:ext cx="20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  <a:endParaRPr lang="el-GR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2E5AAD8-8E5B-010D-E1B3-1ABE8D63EE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1" t="1912" r="48668" b="61189"/>
          <a:stretch>
            <a:fillRect/>
          </a:stretch>
        </p:blipFill>
        <p:spPr>
          <a:xfrm>
            <a:off x="2766772" y="686174"/>
            <a:ext cx="2920073" cy="26393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28E5D1C-AB5B-229A-2013-E4151F886C4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81" t="1280" b="61821"/>
          <a:stretch>
            <a:fillRect/>
          </a:stretch>
        </p:blipFill>
        <p:spPr>
          <a:xfrm>
            <a:off x="138326" y="679724"/>
            <a:ext cx="2770460" cy="261496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5B4813-84E6-6487-098C-16BB73E2C333}"/>
              </a:ext>
            </a:extLst>
          </p:cNvPr>
          <p:cNvSpPr txBox="1"/>
          <p:nvPr/>
        </p:nvSpPr>
        <p:spPr>
          <a:xfrm>
            <a:off x="739127" y="452207"/>
            <a:ext cx="1841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231-control/ PBMC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BD7A08-9103-763E-B772-D2D026AD41EF}"/>
              </a:ext>
            </a:extLst>
          </p:cNvPr>
          <p:cNvSpPr txBox="1"/>
          <p:nvPr/>
        </p:nvSpPr>
        <p:spPr>
          <a:xfrm>
            <a:off x="3518181" y="430690"/>
            <a:ext cx="1746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231-TRAF3/PBMC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C807B6A-73D1-2395-C291-57F3CC2251F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8725" r="4126"/>
          <a:stretch>
            <a:fillRect/>
          </a:stretch>
        </p:blipFill>
        <p:spPr>
          <a:xfrm>
            <a:off x="5553992" y="826459"/>
            <a:ext cx="2616934" cy="246026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5678BA8-F63D-9CBB-49B5-90E1664E5315}"/>
              </a:ext>
            </a:extLst>
          </p:cNvPr>
          <p:cNvSpPr txBox="1"/>
          <p:nvPr/>
        </p:nvSpPr>
        <p:spPr>
          <a:xfrm>
            <a:off x="6321913" y="585602"/>
            <a:ext cx="1532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F7-TRAF3 (alone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A7792A-4CAD-707C-61FA-8DC67C265918}"/>
              </a:ext>
            </a:extLst>
          </p:cNvPr>
          <p:cNvSpPr txBox="1"/>
          <p:nvPr/>
        </p:nvSpPr>
        <p:spPr>
          <a:xfrm>
            <a:off x="8044951" y="216270"/>
            <a:ext cx="20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</a:t>
            </a:r>
            <a:endParaRPr lang="el-GR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D1B6AD-2616-2849-0F13-D442E5C9F219}"/>
              </a:ext>
            </a:extLst>
          </p:cNvPr>
          <p:cNvSpPr txBox="1"/>
          <p:nvPr/>
        </p:nvSpPr>
        <p:spPr>
          <a:xfrm>
            <a:off x="1108345" y="3774564"/>
            <a:ext cx="1865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DA231-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18F262-4DDD-1A2F-374A-49AB4ED9C810}"/>
              </a:ext>
            </a:extLst>
          </p:cNvPr>
          <p:cNvSpPr txBox="1"/>
          <p:nvPr/>
        </p:nvSpPr>
        <p:spPr>
          <a:xfrm>
            <a:off x="4418869" y="3774563"/>
            <a:ext cx="1865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DA231-TRAF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17CB60-6E13-D2EF-1343-7A5B28532511}"/>
              </a:ext>
            </a:extLst>
          </p:cNvPr>
          <p:cNvSpPr txBox="1"/>
          <p:nvPr/>
        </p:nvSpPr>
        <p:spPr>
          <a:xfrm rot="16200000">
            <a:off x="-734360" y="5164402"/>
            <a:ext cx="1865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D-L1 (IC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C31057-765A-D6C5-2998-6FD8369DD4DE}"/>
              </a:ext>
            </a:extLst>
          </p:cNvPr>
          <p:cNvSpPr txBox="1"/>
          <p:nvPr/>
        </p:nvSpPr>
        <p:spPr>
          <a:xfrm>
            <a:off x="8819993" y="3570172"/>
            <a:ext cx="2087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=22 breast cancer cell lines</a:t>
            </a:r>
          </a:p>
        </p:txBody>
      </p:sp>
    </p:spTree>
    <p:extLst>
      <p:ext uri="{BB962C8B-B14F-4D97-AF65-F5344CB8AC3E}">
        <p14:creationId xmlns:p14="http://schemas.microsoft.com/office/powerpoint/2010/main" val="802071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4</TotalTime>
  <Words>5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stasios Papanastasiou</dc:creator>
  <cp:lastModifiedBy>Anastasios Papanastasiou</cp:lastModifiedBy>
  <cp:revision>13</cp:revision>
  <dcterms:created xsi:type="dcterms:W3CDTF">2026-01-11T15:39:46Z</dcterms:created>
  <dcterms:modified xsi:type="dcterms:W3CDTF">2026-01-20T13:39:31Z</dcterms:modified>
</cp:coreProperties>
</file>